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306" r:id="rId2"/>
    <p:sldId id="308" r:id="rId3"/>
    <p:sldId id="309" r:id="rId4"/>
    <p:sldId id="318" r:id="rId5"/>
    <p:sldId id="317" r:id="rId6"/>
    <p:sldId id="314" r:id="rId7"/>
    <p:sldId id="316" r:id="rId8"/>
    <p:sldId id="319" r:id="rId9"/>
    <p:sldId id="313" r:id="rId10"/>
    <p:sldId id="274" r:id="rId11"/>
    <p:sldId id="297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F2FCB03-EA50-0D77-0789-295E5A8FF461}" name="Paola Andréa Martinez Murillo" initials="PAMM" userId="S::Paola.Martinez@unige.ch::2d191d3a-bc8c-480a-9768-18aeffc947d4" providerId="AD"/>
  <p188:author id="{048DB79C-76C6-6AB4-0380-A1E6A58922BD}" name="Arnaud Didierlaurent" initials="AD" userId="S::Arnaud.Didierlaurent@unige.ch::7a0a6071-3f10-47ac-9084-39658912eecc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ola Andréa Martinez Murillo" initials="PAMM" lastIdx="0" clrIdx="0">
    <p:extLst>
      <p:ext uri="{19B8F6BF-5375-455C-9EA6-DF929625EA0E}">
        <p15:presenceInfo xmlns:p15="http://schemas.microsoft.com/office/powerpoint/2012/main" userId="S-1-5-21-2549886845-264585227-397852783-26961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9900"/>
    <a:srgbClr val="FFFF00"/>
    <a:srgbClr val="0000FF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1" autoAdjust="0"/>
    <p:restoredTop sz="93007" autoAdjust="0"/>
  </p:normalViewPr>
  <p:slideViewPr>
    <p:cSldViewPr snapToGrid="0">
      <p:cViewPr>
        <p:scale>
          <a:sx n="80" d="100"/>
          <a:sy n="80" d="100"/>
        </p:scale>
        <p:origin x="1476" y="-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C7F351-B3FD-43BD-9232-96AE7CB2A96D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EE136A-877C-4EBE-A0E6-1B602FEB1730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581280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1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466681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2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284428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3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193939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5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973661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6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2964605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7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0758913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9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2993986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E136A-877C-4EBE-A0E6-1B602FEB1730}" type="slidenum">
              <a:rPr lang="es-CO" smtClean="0"/>
              <a:t>10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35594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50973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64160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69042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73638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59551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615874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74055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38403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22384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837681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142288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A82DF-0E7B-4E3B-A6D6-82F9D509CE25}" type="datetimeFigureOut">
              <a:rPr lang="es-CO" smtClean="0"/>
              <a:t>27/11/2023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455E97-448C-4B42-BED0-235D99A90752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09425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3.emf"/><Relationship Id="rId18" Type="http://schemas.openxmlformats.org/officeDocument/2006/relationships/image" Target="../media/image2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12" Type="http://schemas.openxmlformats.org/officeDocument/2006/relationships/image" Target="../media/image22.emf"/><Relationship Id="rId17" Type="http://schemas.openxmlformats.org/officeDocument/2006/relationships/image" Target="../media/image27.emf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26.emf"/><Relationship Id="rId20" Type="http://schemas.openxmlformats.org/officeDocument/2006/relationships/image" Target="../media/image3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21.emf"/><Relationship Id="rId5" Type="http://schemas.openxmlformats.org/officeDocument/2006/relationships/image" Target="../media/image15.emf"/><Relationship Id="rId15" Type="http://schemas.openxmlformats.org/officeDocument/2006/relationships/image" Target="../media/image25.emf"/><Relationship Id="rId10" Type="http://schemas.openxmlformats.org/officeDocument/2006/relationships/image" Target="../media/image20.emf"/><Relationship Id="rId19" Type="http://schemas.openxmlformats.org/officeDocument/2006/relationships/image" Target="../media/image29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Relationship Id="rId1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/>
          <p:cNvGrpSpPr/>
          <p:nvPr/>
        </p:nvGrpSpPr>
        <p:grpSpPr>
          <a:xfrm>
            <a:off x="610750" y="469873"/>
            <a:ext cx="1550809" cy="712174"/>
            <a:chOff x="649766" y="666761"/>
            <a:chExt cx="1550809" cy="712174"/>
          </a:xfrm>
        </p:grpSpPr>
        <p:sp>
          <p:nvSpPr>
            <p:cNvPr id="41" name="TextBox 40"/>
            <p:cNvSpPr txBox="1"/>
            <p:nvPr/>
          </p:nvSpPr>
          <p:spPr>
            <a:xfrm>
              <a:off x="649766" y="666761"/>
              <a:ext cx="1550809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 Narrow" panose="020B0606020202030204" pitchFamily="34" charset="0"/>
                </a:rPr>
                <a:t>Geneva cohort</a:t>
              </a:r>
            </a:p>
            <a:p>
              <a:pPr algn="ctr"/>
              <a:r>
                <a:rPr lang="en-GB" sz="1200" dirty="0">
                  <a:latin typeface="Arial Narrow" panose="020B0606020202030204" pitchFamily="34" charset="0"/>
                </a:rPr>
                <a:t>115 participants enrolled</a:t>
              </a:r>
            </a:p>
          </p:txBody>
        </p:sp>
        <p:cxnSp>
          <p:nvCxnSpPr>
            <p:cNvPr id="50" name="Straight Connector 49"/>
            <p:cNvCxnSpPr>
              <a:stCxn id="41" idx="2"/>
            </p:cNvCxnSpPr>
            <p:nvPr/>
          </p:nvCxnSpPr>
          <p:spPr>
            <a:xfrm flipH="1">
              <a:off x="1425170" y="1128426"/>
              <a:ext cx="1" cy="2505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2" name="Straight Connector 51"/>
          <p:cNvCxnSpPr/>
          <p:nvPr/>
        </p:nvCxnSpPr>
        <p:spPr>
          <a:xfrm>
            <a:off x="381715" y="1171896"/>
            <a:ext cx="1974851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381716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7706" y="1528516"/>
            <a:ext cx="621628" cy="58477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35 participants received </a:t>
            </a:r>
            <a:r>
              <a:rPr lang="en-GB" sz="800" b="1" dirty="0">
                <a:latin typeface="Arial Narrow" panose="020B0606020202030204" pitchFamily="34" charset="0"/>
              </a:rPr>
              <a:t>1x10</a:t>
            </a:r>
            <a:r>
              <a:rPr lang="en-GB" sz="800" b="1" baseline="30000" dirty="0">
                <a:latin typeface="Arial Narrow" panose="020B0606020202030204" pitchFamily="34" charset="0"/>
              </a:rPr>
              <a:t>7</a:t>
            </a:r>
          </a:p>
        </p:txBody>
      </p:sp>
      <p:cxnSp>
        <p:nvCxnSpPr>
          <p:cNvPr id="59" name="Straight Arrow Connector 58"/>
          <p:cNvCxnSpPr/>
          <p:nvPr/>
        </p:nvCxnSpPr>
        <p:spPr>
          <a:xfrm>
            <a:off x="1039277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708106" y="1528516"/>
            <a:ext cx="640678" cy="58477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16 participants received </a:t>
            </a:r>
            <a:r>
              <a:rPr lang="en-GB" sz="800" b="1" dirty="0">
                <a:latin typeface="Arial Narrow" panose="020B0606020202030204" pitchFamily="34" charset="0"/>
              </a:rPr>
              <a:t>5x10</a:t>
            </a:r>
            <a:r>
              <a:rPr lang="en-GB" sz="800" b="1" baseline="30000" dirty="0">
                <a:latin typeface="Arial Narrow" panose="020B0606020202030204" pitchFamily="34" charset="0"/>
              </a:rPr>
              <a:t>7</a:t>
            </a:r>
          </a:p>
        </p:txBody>
      </p:sp>
      <p:cxnSp>
        <p:nvCxnSpPr>
          <p:cNvPr id="62" name="Straight Arrow Connector 61"/>
          <p:cNvCxnSpPr/>
          <p:nvPr/>
        </p:nvCxnSpPr>
        <p:spPr>
          <a:xfrm>
            <a:off x="1734266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1381206" y="1528516"/>
            <a:ext cx="636138" cy="58477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9050">
            <a:solidFill>
              <a:srgbClr val="0099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51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5</a:t>
            </a:r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2356566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2054307" y="1528516"/>
            <a:ext cx="615278" cy="584775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13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participants received a </a:t>
            </a:r>
            <a:r>
              <a:rPr lang="en-GB" sz="800" b="1" dirty="0">
                <a:latin typeface="Arial Narrow" panose="020B0606020202030204" pitchFamily="34" charset="0"/>
              </a:rPr>
              <a:t>placebo</a:t>
            </a:r>
            <a:endParaRPr lang="en-GB" sz="800" b="1" baseline="30000" dirty="0">
              <a:latin typeface="Arial Narrow" panose="020B060602020203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7707" y="3363871"/>
            <a:ext cx="1304831" cy="33855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High dose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 51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1391309" y="3363871"/>
            <a:ext cx="619685" cy="338554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9050">
            <a:solidFill>
              <a:srgbClr val="0099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Low dose 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51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054307" y="3363871"/>
            <a:ext cx="612383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Placebo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13</a:t>
            </a:r>
          </a:p>
        </p:txBody>
      </p:sp>
      <p:grpSp>
        <p:nvGrpSpPr>
          <p:cNvPr id="76" name="Group 75"/>
          <p:cNvGrpSpPr/>
          <p:nvPr/>
        </p:nvGrpSpPr>
        <p:grpSpPr>
          <a:xfrm>
            <a:off x="4101844" y="465811"/>
            <a:ext cx="1560043" cy="712174"/>
            <a:chOff x="994399" y="666761"/>
            <a:chExt cx="1560043" cy="712174"/>
          </a:xfrm>
        </p:grpSpPr>
        <p:sp>
          <p:nvSpPr>
            <p:cNvPr id="77" name="TextBox 76"/>
            <p:cNvSpPr txBox="1"/>
            <p:nvPr/>
          </p:nvSpPr>
          <p:spPr>
            <a:xfrm>
              <a:off x="994399" y="666761"/>
              <a:ext cx="1560043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latin typeface="Arial Narrow" panose="020B0606020202030204" pitchFamily="34" charset="0"/>
                </a:rPr>
                <a:t>USA cohort</a:t>
              </a:r>
            </a:p>
            <a:p>
              <a:pPr algn="ctr"/>
              <a:r>
                <a:rPr lang="en-GB" sz="1200" dirty="0">
                  <a:latin typeface="Arial Narrow" panose="020B0606020202030204" pitchFamily="34" charset="0"/>
                </a:rPr>
                <a:t>513 participants enrolled</a:t>
              </a:r>
            </a:p>
          </p:txBody>
        </p:sp>
        <p:cxnSp>
          <p:nvCxnSpPr>
            <p:cNvPr id="78" name="Straight Connector 77"/>
            <p:cNvCxnSpPr>
              <a:stCxn id="77" idx="2"/>
            </p:cNvCxnSpPr>
            <p:nvPr/>
          </p:nvCxnSpPr>
          <p:spPr>
            <a:xfrm>
              <a:off x="1774421" y="1128426"/>
              <a:ext cx="0" cy="2505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8" name="Straight Arrow Connector 97"/>
          <p:cNvCxnSpPr/>
          <p:nvPr/>
        </p:nvCxnSpPr>
        <p:spPr>
          <a:xfrm flipH="1">
            <a:off x="381715" y="2129657"/>
            <a:ext cx="6351" cy="12342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>
            <a:off x="1039277" y="2129657"/>
            <a:ext cx="0" cy="12342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>
            <a:stCxn id="63" idx="2"/>
            <a:endCxn id="73" idx="0"/>
          </p:cNvCxnSpPr>
          <p:nvPr/>
        </p:nvCxnSpPr>
        <p:spPr>
          <a:xfrm>
            <a:off x="1699275" y="2113291"/>
            <a:ext cx="1877" cy="125058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>
            <a:endCxn id="75" idx="0"/>
          </p:cNvCxnSpPr>
          <p:nvPr/>
        </p:nvCxnSpPr>
        <p:spPr>
          <a:xfrm>
            <a:off x="2356566" y="2129657"/>
            <a:ext cx="3933" cy="12342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3201115" y="1173491"/>
            <a:ext cx="3285792" cy="2573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3201116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2879806" y="1528516"/>
            <a:ext cx="621628" cy="584775"/>
          </a:xfrm>
          <a:prstGeom prst="rect">
            <a:avLst/>
          </a:prstGeom>
          <a:solidFill>
            <a:srgbClr val="FF6699">
              <a:alpha val="50196"/>
            </a:srgbClr>
          </a:solidFill>
          <a:ln w="19050">
            <a:solidFill>
              <a:srgbClr val="FF669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47 participants received </a:t>
            </a:r>
            <a:r>
              <a:rPr lang="en-GB" sz="800" b="1" dirty="0">
                <a:latin typeface="Arial Narrow" panose="020B0606020202030204" pitchFamily="34" charset="0"/>
              </a:rPr>
              <a:t>1x10</a:t>
            </a:r>
            <a:r>
              <a:rPr lang="en-GB" sz="800" b="1" baseline="30000" dirty="0">
                <a:latin typeface="Arial Narrow" panose="020B0606020202030204" pitchFamily="34" charset="0"/>
              </a:rPr>
              <a:t>8</a:t>
            </a:r>
          </a:p>
        </p:txBody>
      </p:sp>
      <p:cxnSp>
        <p:nvCxnSpPr>
          <p:cNvPr id="106" name="Straight Arrow Connector 105"/>
          <p:cNvCxnSpPr/>
          <p:nvPr/>
        </p:nvCxnSpPr>
        <p:spPr>
          <a:xfrm>
            <a:off x="3858677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3533856" y="1528516"/>
            <a:ext cx="640678" cy="584775"/>
          </a:xfrm>
          <a:prstGeom prst="rect">
            <a:avLst/>
          </a:prstGeom>
          <a:solidFill>
            <a:srgbClr val="FF6699">
              <a:alpha val="50196"/>
            </a:srgbClr>
          </a:solidFill>
          <a:ln w="19050">
            <a:solidFill>
              <a:srgbClr val="FF669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47 participants received </a:t>
            </a:r>
            <a:r>
              <a:rPr lang="en-GB" sz="800" b="1" dirty="0">
                <a:latin typeface="Arial Narrow" panose="020B0606020202030204" pitchFamily="34" charset="0"/>
              </a:rPr>
              <a:t>2x10</a:t>
            </a:r>
            <a:r>
              <a:rPr lang="en-GB" sz="800" b="1" baseline="30000" dirty="0">
                <a:latin typeface="Arial Narrow" panose="020B0606020202030204" pitchFamily="34" charset="0"/>
              </a:rPr>
              <a:t>7</a:t>
            </a: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4534616" y="11835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4213306" y="1528516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64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5</a:t>
            </a:r>
          </a:p>
        </p:txBody>
      </p:sp>
      <p:cxnSp>
        <p:nvCxnSpPr>
          <p:cNvPr id="110" name="Straight Arrow Connector 109"/>
          <p:cNvCxnSpPr/>
          <p:nvPr/>
        </p:nvCxnSpPr>
        <p:spPr>
          <a:xfrm>
            <a:off x="5197857" y="1196002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6213557" y="1528516"/>
            <a:ext cx="615278" cy="584775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94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participants received a </a:t>
            </a:r>
            <a:r>
              <a:rPr lang="en-GB" sz="800" b="1" dirty="0">
                <a:latin typeface="Arial Narrow" panose="020B0606020202030204" pitchFamily="34" charset="0"/>
              </a:rPr>
              <a:t>placebo</a:t>
            </a:r>
            <a:endParaRPr lang="en-GB" sz="800" b="1" baseline="30000" dirty="0">
              <a:latin typeface="Arial Narrow" panose="020B0606020202030204" pitchFamily="34" charset="0"/>
            </a:endParaRPr>
          </a:p>
        </p:txBody>
      </p:sp>
      <p:cxnSp>
        <p:nvCxnSpPr>
          <p:cNvPr id="115" name="Straight Arrow Connector 114"/>
          <p:cNvCxnSpPr/>
          <p:nvPr/>
        </p:nvCxnSpPr>
        <p:spPr>
          <a:xfrm>
            <a:off x="3220166" y="21296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>
            <a:off x="3871377" y="21296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/>
          <p:cNvCxnSpPr/>
          <p:nvPr/>
        </p:nvCxnSpPr>
        <p:spPr>
          <a:xfrm>
            <a:off x="4566366" y="21296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4881866" y="1528516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64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4</a:t>
            </a:r>
          </a:p>
        </p:txBody>
      </p:sp>
      <p:cxnSp>
        <p:nvCxnSpPr>
          <p:cNvPr id="121" name="Straight Arrow Connector 120"/>
          <p:cNvCxnSpPr/>
          <p:nvPr/>
        </p:nvCxnSpPr>
        <p:spPr>
          <a:xfrm>
            <a:off x="5234926" y="21296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5550426" y="1528516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64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3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2879806" y="2458454"/>
            <a:ext cx="621628" cy="584775"/>
          </a:xfrm>
          <a:prstGeom prst="rect">
            <a:avLst/>
          </a:prstGeom>
          <a:solidFill>
            <a:srgbClr val="FF6699">
              <a:alpha val="50196"/>
            </a:srgbClr>
          </a:solidFill>
          <a:ln w="19050">
            <a:solidFill>
              <a:srgbClr val="FF669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30 participants received </a:t>
            </a:r>
            <a:r>
              <a:rPr lang="en-GB" sz="800" b="1" dirty="0">
                <a:latin typeface="Arial Narrow" panose="020B0606020202030204" pitchFamily="34" charset="0"/>
              </a:rPr>
              <a:t>1x10</a:t>
            </a:r>
            <a:r>
              <a:rPr lang="en-GB" sz="800" b="1" baseline="30000" dirty="0">
                <a:latin typeface="Arial Narrow" panose="020B0606020202030204" pitchFamily="34" charset="0"/>
              </a:rPr>
              <a:t>8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3533856" y="2458454"/>
            <a:ext cx="640678" cy="584775"/>
          </a:xfrm>
          <a:prstGeom prst="rect">
            <a:avLst/>
          </a:prstGeom>
          <a:solidFill>
            <a:srgbClr val="FF6699">
              <a:alpha val="50196"/>
            </a:srgbClr>
          </a:solidFill>
          <a:ln w="19050">
            <a:solidFill>
              <a:srgbClr val="FF669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30 participants received </a:t>
            </a:r>
            <a:r>
              <a:rPr lang="en-GB" sz="800" b="1" dirty="0">
                <a:latin typeface="Arial Narrow" panose="020B0606020202030204" pitchFamily="34" charset="0"/>
              </a:rPr>
              <a:t>2x10</a:t>
            </a:r>
            <a:r>
              <a:rPr lang="en-GB" sz="800" b="1" baseline="30000" dirty="0">
                <a:latin typeface="Arial Narrow" panose="020B0606020202030204" pitchFamily="34" charset="0"/>
              </a:rPr>
              <a:t>7</a:t>
            </a:r>
          </a:p>
        </p:txBody>
      </p:sp>
      <p:cxnSp>
        <p:nvCxnSpPr>
          <p:cNvPr id="125" name="Straight Arrow Connector 124"/>
          <p:cNvCxnSpPr/>
          <p:nvPr/>
        </p:nvCxnSpPr>
        <p:spPr>
          <a:xfrm>
            <a:off x="5855416" y="119620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/>
          <p:nvPr/>
        </p:nvCxnSpPr>
        <p:spPr>
          <a:xfrm>
            <a:off x="6486907" y="1208702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4213306" y="2458079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34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5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6213557" y="2458079"/>
            <a:ext cx="615278" cy="584775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22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participants received a </a:t>
            </a:r>
            <a:r>
              <a:rPr lang="en-GB" sz="800" b="1" dirty="0">
                <a:latin typeface="Arial Narrow" panose="020B0606020202030204" pitchFamily="34" charset="0"/>
              </a:rPr>
              <a:t>placebo</a:t>
            </a:r>
            <a:endParaRPr lang="en-GB" sz="800" b="1" baseline="30000" dirty="0">
              <a:latin typeface="Arial Narrow" panose="020B060602020203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881866" y="2458079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6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4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5550426" y="2458079"/>
            <a:ext cx="636138" cy="58477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8 participants received </a:t>
            </a:r>
            <a:r>
              <a:rPr lang="en-GB" sz="800" b="1" dirty="0">
                <a:latin typeface="Arial Narrow" panose="020B0606020202030204" pitchFamily="34" charset="0"/>
              </a:rPr>
              <a:t>3x10</a:t>
            </a:r>
            <a:r>
              <a:rPr lang="en-GB" sz="800" b="1" baseline="30000" dirty="0">
                <a:latin typeface="Arial Narrow" panose="020B0606020202030204" pitchFamily="34" charset="0"/>
              </a:rPr>
              <a:t>3</a:t>
            </a:r>
          </a:p>
        </p:txBody>
      </p:sp>
      <p:cxnSp>
        <p:nvCxnSpPr>
          <p:cNvPr id="133" name="Straight Arrow Connector 132"/>
          <p:cNvCxnSpPr/>
          <p:nvPr/>
        </p:nvCxnSpPr>
        <p:spPr>
          <a:xfrm>
            <a:off x="5861766" y="21169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>
            <a:off x="6493257" y="2129452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/>
          <p:nvPr/>
        </p:nvCxnSpPr>
        <p:spPr>
          <a:xfrm>
            <a:off x="3226516" y="30440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/>
          <p:nvPr/>
        </p:nvCxnSpPr>
        <p:spPr>
          <a:xfrm>
            <a:off x="3877727" y="30440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/>
          <p:cNvCxnSpPr/>
          <p:nvPr/>
        </p:nvCxnSpPr>
        <p:spPr>
          <a:xfrm>
            <a:off x="4572716" y="30440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/>
          <p:nvPr/>
        </p:nvCxnSpPr>
        <p:spPr>
          <a:xfrm>
            <a:off x="5241276" y="30440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/>
          <p:nvPr/>
        </p:nvCxnSpPr>
        <p:spPr>
          <a:xfrm>
            <a:off x="5868116" y="3031357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/>
          <p:cNvCxnSpPr/>
          <p:nvPr/>
        </p:nvCxnSpPr>
        <p:spPr>
          <a:xfrm>
            <a:off x="6499607" y="3043852"/>
            <a:ext cx="0" cy="33251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2879806" y="3363871"/>
            <a:ext cx="1294728" cy="338554"/>
          </a:xfrm>
          <a:prstGeom prst="rect">
            <a:avLst/>
          </a:prstGeom>
          <a:solidFill>
            <a:srgbClr val="FF6699">
              <a:alpha val="50196"/>
            </a:srgbClr>
          </a:solidFill>
          <a:ln w="19050">
            <a:solidFill>
              <a:srgbClr val="FF669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High dose 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60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4212185" y="3363871"/>
            <a:ext cx="1974379" cy="33855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66FF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Low dose 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48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6213135" y="3363871"/>
            <a:ext cx="615700" cy="338554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 Narrow" panose="020B0606020202030204" pitchFamily="34" charset="0"/>
              </a:rPr>
              <a:t>Placebo</a:t>
            </a:r>
          </a:p>
          <a:p>
            <a:pPr algn="ctr"/>
            <a:r>
              <a:rPr lang="en-GB" sz="800" dirty="0">
                <a:latin typeface="Arial Narrow" panose="020B0606020202030204" pitchFamily="34" charset="0"/>
              </a:rPr>
              <a:t>n=22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-3471" y="17155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61" name="Rectangle 60"/>
          <p:cNvSpPr/>
          <p:nvPr/>
        </p:nvSpPr>
        <p:spPr>
          <a:xfrm>
            <a:off x="-359" y="4022239"/>
            <a:ext cx="685304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Study flow chart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diagram of the distribution of participants enrolled in Geneva and US cohorts. Groups with different doses but with similar cytokine response were pooled as indicated in the diagram. </a:t>
            </a:r>
          </a:p>
        </p:txBody>
      </p:sp>
    </p:spTree>
    <p:extLst>
      <p:ext uri="{BB962C8B-B14F-4D97-AF65-F5344CB8AC3E}">
        <p14:creationId xmlns:p14="http://schemas.microsoft.com/office/powerpoint/2010/main" val="32597726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-3471" y="20579"/>
            <a:ext cx="2467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827" y="796061"/>
            <a:ext cx="5378450" cy="35115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-3471" y="375163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of the geometric mean (GM) of the markers included in the refined signature in US participants. </a:t>
            </a:r>
            <a:endParaRPr lang="es-C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-3471" y="4451510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tio of GM: log10 base ratio Day 1/Day 0. Significant difference between day 1 and day0 represented by P-values in bold. Markers are presented according to the ratio GM levels in the high dose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2316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3471" y="46651"/>
            <a:ext cx="2514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731047" y="552914"/>
            <a:ext cx="1598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000" dirty="0">
                <a:latin typeface="Arial Narrow" panose="020B0606020202030204" pitchFamily="34" charset="0"/>
              </a:rPr>
              <a:t>Geneva data with US equat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918397" y="552914"/>
            <a:ext cx="1598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000" dirty="0">
                <a:latin typeface="Arial Narrow" panose="020B0606020202030204" pitchFamily="34" charset="0"/>
              </a:rPr>
              <a:t>US data with Geneva equatio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31604" y="552914"/>
            <a:ext cx="1378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sz="1000" dirty="0">
                <a:latin typeface="Arial Narrow" panose="020B0606020202030204" pitchFamily="34" charset="0"/>
              </a:rPr>
              <a:t>US data with US equatio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699" y="31963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02447" y="31963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387099" y="3196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Rectangle 14"/>
          <p:cNvSpPr/>
          <p:nvPr/>
        </p:nvSpPr>
        <p:spPr>
          <a:xfrm>
            <a:off x="4953" y="2922782"/>
            <a:ext cx="685304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Component 1 discrimination between low dose and high dose. 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data and equatio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va data and US equat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data and Geneva equation. Low dose in blue and High dose in red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6A8B88A-CA54-EAA1-99DC-BC95E7D71A5D}"/>
              </a:ext>
            </a:extLst>
          </p:cNvPr>
          <p:cNvSpPr txBox="1"/>
          <p:nvPr/>
        </p:nvSpPr>
        <p:spPr>
          <a:xfrm>
            <a:off x="985608" y="2477461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1</a:t>
            </a:r>
          </a:p>
        </p:txBody>
      </p:sp>
      <p:pic>
        <p:nvPicPr>
          <p:cNvPr id="1033" name="Picture 9">
            <a:extLst>
              <a:ext uri="{FF2B5EF4-FFF2-40B4-BE49-F238E27FC236}">
                <a16:creationId xmlns:a16="http://schemas.microsoft.com/office/drawing/2014/main" id="{6E8CFEB4-BF6F-416D-D3BA-9725FEA0A29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2" t="8022" r="3289" b="7191"/>
          <a:stretch/>
        </p:blipFill>
        <p:spPr bwMode="auto">
          <a:xfrm>
            <a:off x="329130" y="777544"/>
            <a:ext cx="1911986" cy="1757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A57C263-2EF5-A573-9080-BF23233AEC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09" t="7702" r="4181" b="6827"/>
          <a:stretch/>
        </p:blipFill>
        <p:spPr>
          <a:xfrm>
            <a:off x="2538575" y="768409"/>
            <a:ext cx="1894739" cy="177166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5A8FA6E-C880-CEDE-9A07-612111CBDB8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78" t="7767" r="4048" b="6826"/>
          <a:stretch/>
        </p:blipFill>
        <p:spPr>
          <a:xfrm>
            <a:off x="4741307" y="772520"/>
            <a:ext cx="1894739" cy="1770321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25CEEB9-5DDE-DB62-729A-9108171FF033}"/>
              </a:ext>
            </a:extLst>
          </p:cNvPr>
          <p:cNvSpPr txBox="1"/>
          <p:nvPr/>
        </p:nvSpPr>
        <p:spPr>
          <a:xfrm>
            <a:off x="3171073" y="2479031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907DCC5-0D16-E027-E4CD-ADBB8A820E22}"/>
              </a:ext>
            </a:extLst>
          </p:cNvPr>
          <p:cNvSpPr txBox="1"/>
          <p:nvPr/>
        </p:nvSpPr>
        <p:spPr>
          <a:xfrm>
            <a:off x="5372242" y="2477459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E411156-034C-8D76-605B-1CEDAA8C6FEB}"/>
              </a:ext>
            </a:extLst>
          </p:cNvPr>
          <p:cNvSpPr txBox="1"/>
          <p:nvPr/>
        </p:nvSpPr>
        <p:spPr>
          <a:xfrm rot="16200000">
            <a:off x="4331352" y="1444788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4E3B0B0-E38F-9094-A328-077A84B0F04A}"/>
              </a:ext>
            </a:extLst>
          </p:cNvPr>
          <p:cNvSpPr txBox="1"/>
          <p:nvPr/>
        </p:nvSpPr>
        <p:spPr>
          <a:xfrm rot="16200000">
            <a:off x="2127043" y="1446360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D29CF54-4C01-8175-D295-E4666B8BFFAC}"/>
              </a:ext>
            </a:extLst>
          </p:cNvPr>
          <p:cNvSpPr txBox="1"/>
          <p:nvPr/>
        </p:nvSpPr>
        <p:spPr>
          <a:xfrm rot="16200000">
            <a:off x="-80410" y="1444788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 Narrow" panose="020B0606020202030204" pitchFamily="34" charset="0"/>
              </a:rPr>
              <a:t>Component 2</a:t>
            </a:r>
          </a:p>
        </p:txBody>
      </p:sp>
    </p:spTree>
    <p:extLst>
      <p:ext uri="{BB962C8B-B14F-4D97-AF65-F5344CB8AC3E}">
        <p14:creationId xmlns:p14="http://schemas.microsoft.com/office/powerpoint/2010/main" val="3996843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4098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9648" y="7214617"/>
            <a:ext cx="6816715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Representation of the level of O-link markers measured in plasma of Geneva vaccinees cohort (high and low dose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s representing O-link inflammatory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etabolic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s panels of the low dose group displaying the log10 fold change (x axis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the t-test-derived negative log10 statistical P-value (y axis) for all proteins differentially secreted betwee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y1 and day0 (data from the high dose groups in shown in Fig 1C,D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sholds (dotted grey line): p-value cut-off was fixed at 0.05 (1,3 negative log10) and fold change cut-offs is 1 (0 in the log10 scale. Open circles represent all proteins below the p-value and in dark grey all proteins below fold change cut-offs. Proteins above the fold-change cut off are labelled as green circle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 map of the ratio D1, D3 and D7 over D0 for inflammatory panel marker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etabolism and Immune panels marker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ich were not significantly different when compared to D0.  </a:t>
            </a: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897" y="466561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897" y="32283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8927" y="33984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605523" y="33984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O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9757" y="3325164"/>
            <a:ext cx="1260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Inflammatory panel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29757" y="4792646"/>
            <a:ext cx="18726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Metabolic and Immune panels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r="7857"/>
          <a:stretch/>
        </p:blipFill>
        <p:spPr>
          <a:xfrm>
            <a:off x="47329" y="3449848"/>
            <a:ext cx="6810671" cy="12192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b="6720"/>
          <a:stretch/>
        </p:blipFill>
        <p:spPr>
          <a:xfrm>
            <a:off x="0" y="5000104"/>
            <a:ext cx="6877431" cy="13663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6218" y="6392060"/>
            <a:ext cx="1276350" cy="7493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64211" y="6392060"/>
            <a:ext cx="1276350" cy="7493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B6BBB94-894E-4D09-D402-8C828FF1C4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329" y="652890"/>
            <a:ext cx="3049588" cy="270954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1238C51-D086-7A00-0EA5-FF759D074EB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97361" y="652889"/>
            <a:ext cx="3044190" cy="2747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85177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2285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</a:p>
        </p:txBody>
      </p:sp>
      <p:sp>
        <p:nvSpPr>
          <p:cNvPr id="4" name="Rectangle 3"/>
          <p:cNvSpPr/>
          <p:nvPr/>
        </p:nvSpPr>
        <p:spPr>
          <a:xfrm>
            <a:off x="41285" y="6940961"/>
            <a:ext cx="681671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Biomarker correlation matrix (Geneva cohort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’s correlation coefficients (rho) between cytokines/chemokines measured by Luminex (see Fig 2). Red fill rectangles show the correlations values between the markers constituting the previously described signature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(Huttner, 2017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additional markers measured here. Orange fill rectangles highlight the correlation values between those additional markers only (highlighted in the orange box). Values closer to 0 are shown in grey and values closer to 1 are shown in red or orange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ly significant correlations are shown in bold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96F284A-9B06-88A8-CCF4-0498F5A81ED2}"/>
              </a:ext>
            </a:extLst>
          </p:cNvPr>
          <p:cNvSpPr/>
          <p:nvPr/>
        </p:nvSpPr>
        <p:spPr>
          <a:xfrm>
            <a:off x="358706" y="1828800"/>
            <a:ext cx="523889" cy="1800225"/>
          </a:xfrm>
          <a:prstGeom prst="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BEA2D66-51D6-6DF4-1EC2-E647E8628308}"/>
              </a:ext>
            </a:extLst>
          </p:cNvPr>
          <p:cNvSpPr/>
          <p:nvPr/>
        </p:nvSpPr>
        <p:spPr>
          <a:xfrm>
            <a:off x="358706" y="5087739"/>
            <a:ext cx="523889" cy="1800225"/>
          </a:xfrm>
          <a:prstGeom prst="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32FB0BE-77DE-3244-5E41-0713B071AE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462" y="336961"/>
            <a:ext cx="5632450" cy="6692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79400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E3D8658-5FE4-CB62-42A9-6B0548EF9121}"/>
              </a:ext>
            </a:extLst>
          </p:cNvPr>
          <p:cNvSpPr txBox="1"/>
          <p:nvPr/>
        </p:nvSpPr>
        <p:spPr>
          <a:xfrm>
            <a:off x="-3471" y="46651"/>
            <a:ext cx="2480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46DB4C3-0B0E-95DD-CBAB-AB8C9479D4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727" y="692982"/>
            <a:ext cx="5543550" cy="56515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DF83635-1B53-7E30-D485-14FF46801EF4}"/>
              </a:ext>
            </a:extLst>
          </p:cNvPr>
          <p:cNvSpPr/>
          <p:nvPr/>
        </p:nvSpPr>
        <p:spPr>
          <a:xfrm>
            <a:off x="-3471" y="6344482"/>
            <a:ext cx="685304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ometric mean log10-base ratio (day1/day0) with 95% confidence interval were compared between arthritis and non-arthritis participants using t-test.</a:t>
            </a: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66B894-E360-8B60-FE45-AEC214038A34}"/>
              </a:ext>
            </a:extLst>
          </p:cNvPr>
          <p:cNvSpPr txBox="1"/>
          <p:nvPr/>
        </p:nvSpPr>
        <p:spPr>
          <a:xfrm>
            <a:off x="-3471" y="415983"/>
            <a:ext cx="49088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-link data comparison between no arthritis and  arthritis </a:t>
            </a:r>
          </a:p>
        </p:txBody>
      </p:sp>
    </p:spTree>
    <p:extLst>
      <p:ext uri="{BB962C8B-B14F-4D97-AF65-F5344CB8AC3E}">
        <p14:creationId xmlns:p14="http://schemas.microsoft.com/office/powerpoint/2010/main" val="16827065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574553"/>
            <a:ext cx="68579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efficients of the equation for the two retained principal components</a:t>
            </a:r>
          </a:p>
        </p:txBody>
      </p:sp>
      <p:sp>
        <p:nvSpPr>
          <p:cNvPr id="4" name="Rectangle 3"/>
          <p:cNvSpPr/>
          <p:nvPr/>
        </p:nvSpPr>
        <p:spPr>
          <a:xfrm>
            <a:off x="0" y="22478"/>
            <a:ext cx="2416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8ADEAAD-7616-EAB1-9E59-53DEC1F096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717" y="851552"/>
            <a:ext cx="2667000" cy="3917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98451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-3472" y="0"/>
            <a:ext cx="67808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table 3</a:t>
            </a:r>
            <a:endParaRPr lang="en-US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-3472" y="321207"/>
            <a:ext cx="686147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between the components score of the refined signature with the biological outcomes in the low and high vaccine dose groups in the Geneva cohort</a:t>
            </a:r>
            <a:endParaRPr lang="es-CO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-3472" y="4556327"/>
            <a:ext cx="68579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efficients of correlation Spearman (p-value).</a:t>
            </a:r>
            <a:endParaRPr lang="es-C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5325" y="733627"/>
            <a:ext cx="5467350" cy="382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12974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2467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4</a:t>
            </a:r>
            <a:endParaRPr lang="es-CO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0" y="334396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t map of Spearman’s correlation coefficients between the biological outcomes and additional biomarkers ratio (day1/day0) in Geneva cohort</a:t>
            </a:r>
            <a:endParaRPr lang="es-C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0" y="5328694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from 0 to 1 are shown in shades from white to red. Values from -1 to 0 are shown in shades from blue to white. Statistically significant correlations are shown in bold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CB40A5C-D3A5-AF23-0AF8-0ED8620D73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7175" y="796061"/>
            <a:ext cx="6343650" cy="445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9781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2F6A09-44A1-C246-127F-8EB33D795B3C}"/>
              </a:ext>
            </a:extLst>
          </p:cNvPr>
          <p:cNvSpPr txBox="1"/>
          <p:nvPr/>
        </p:nvSpPr>
        <p:spPr>
          <a:xfrm>
            <a:off x="-3471" y="46651"/>
            <a:ext cx="2572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F77A8CB-2B10-538C-AEB3-D519038D9661}"/>
              </a:ext>
            </a:extLst>
          </p:cNvPr>
          <p:cNvSpPr/>
          <p:nvPr/>
        </p:nvSpPr>
        <p:spPr>
          <a:xfrm>
            <a:off x="0" y="334396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at map of Spearman’s correlation coefficients between the GP-ELISA units/mL and the biomarkers ratio </a:t>
            </a:r>
            <a:endParaRPr lang="es-C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D8B1308-0CF2-870D-063C-E400FCDF0257}"/>
              </a:ext>
            </a:extLst>
          </p:cNvPr>
          <p:cNvSpPr/>
          <p:nvPr/>
        </p:nvSpPr>
        <p:spPr>
          <a:xfrm>
            <a:off x="0" y="5810168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from 0 to 1 are shown in shades from white to red. Values from -1 to 0 are shown in shades from blue to white. Statistically significant correlations are shown in bold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628AD60-2D0A-5A35-57AA-E404543A11F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95" r="3839" b="2214"/>
          <a:stretch/>
        </p:blipFill>
        <p:spPr>
          <a:xfrm>
            <a:off x="126347" y="796060"/>
            <a:ext cx="6593700" cy="5014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60585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/>
        </p:nvSpPr>
        <p:spPr>
          <a:xfrm>
            <a:off x="-13801" y="6126531"/>
            <a:ext cx="685304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Level of selected plasma biomarkers at day 1 after vaccination in USA participant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minex concentration in pg/ml for each marker was plotted at day 0 and day1: placebo (gray), low dose (blue) and high dose (pink). Each dot represents a participant (n=130). Black lines represent 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ometric mean concentrations with 95% CI. Red dotted lines indicate the limit of detection for each marker. Samples below the limit of detection were assigned a value corresponding to 50% of the last standard dilution valu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-3471" y="46651"/>
            <a:ext cx="2572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9CB5BD2-E684-6669-1957-95642A709F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583"/>
          <a:stretch/>
        </p:blipFill>
        <p:spPr>
          <a:xfrm>
            <a:off x="361277" y="521143"/>
            <a:ext cx="1441450" cy="148818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BF841E7-773B-FE37-5300-85DC83FEB19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057" r="14346"/>
          <a:stretch/>
        </p:blipFill>
        <p:spPr>
          <a:xfrm>
            <a:off x="3904884" y="1889637"/>
            <a:ext cx="1162051" cy="14881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766B20C-2F65-4639-3571-DCA87FFF4BF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127" r="14366"/>
          <a:stretch/>
        </p:blipFill>
        <p:spPr>
          <a:xfrm>
            <a:off x="3851971" y="3266190"/>
            <a:ext cx="1225550" cy="148818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695489F-DC2C-3EB2-1866-A363B3968FE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494" r="14891"/>
          <a:stretch/>
        </p:blipFill>
        <p:spPr>
          <a:xfrm>
            <a:off x="2725486" y="3260564"/>
            <a:ext cx="1162359" cy="148818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E02D53A-DFF4-E9CD-43D3-9C19CD6563F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2875" r="14592"/>
          <a:stretch/>
        </p:blipFill>
        <p:spPr>
          <a:xfrm>
            <a:off x="2764790" y="529944"/>
            <a:ext cx="1143000" cy="148818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0E3B1F5-0248-D7C4-B652-16842E6093B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3397" r="14227"/>
          <a:stretch/>
        </p:blipFill>
        <p:spPr>
          <a:xfrm>
            <a:off x="65302" y="4631590"/>
            <a:ext cx="1123951" cy="148818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58B1DD5-0DAF-C76C-FB44-5FCDC7C4388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1809" r="15098"/>
          <a:stretch/>
        </p:blipFill>
        <p:spPr>
          <a:xfrm>
            <a:off x="1090624" y="4628983"/>
            <a:ext cx="1219201" cy="148818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B7BBF4E-53C1-4218-5E05-0DD9FEA5120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3146" r="14475"/>
          <a:stretch/>
        </p:blipFill>
        <p:spPr>
          <a:xfrm>
            <a:off x="2248312" y="4628588"/>
            <a:ext cx="1174750" cy="148818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6824462-B79E-4D30-0AA7-235C74061989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3087" r="14535"/>
          <a:stretch/>
        </p:blipFill>
        <p:spPr>
          <a:xfrm>
            <a:off x="1557460" y="510221"/>
            <a:ext cx="1174751" cy="149733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720E4FF-6B1B-A343-2153-8DFE2EA56CF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2393" r="14836"/>
          <a:stretch/>
        </p:blipFill>
        <p:spPr>
          <a:xfrm>
            <a:off x="384095" y="3262761"/>
            <a:ext cx="1181101" cy="148818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7866D5C-CA6E-3EDA-9FE3-A3A7D253E620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2540" r="13225"/>
          <a:stretch/>
        </p:blipFill>
        <p:spPr>
          <a:xfrm>
            <a:off x="1503861" y="3260564"/>
            <a:ext cx="1238251" cy="148818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879FAC5-8FFA-A0CF-1551-D1D61046394D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1759" r="12990"/>
          <a:stretch/>
        </p:blipFill>
        <p:spPr>
          <a:xfrm>
            <a:off x="288346" y="1885296"/>
            <a:ext cx="1289050" cy="149733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B603D85-17BA-17B9-8C69-EE7526610B9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13636" r="13829"/>
          <a:stretch/>
        </p:blipFill>
        <p:spPr>
          <a:xfrm>
            <a:off x="3943350" y="529078"/>
            <a:ext cx="1143000" cy="148818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8D9CF55B-814E-9465-1B2A-C5593FABC8F9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12839" r="14068"/>
          <a:stretch/>
        </p:blipFill>
        <p:spPr>
          <a:xfrm>
            <a:off x="4391399" y="4631983"/>
            <a:ext cx="1219201" cy="1488186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879E8A41-ACE3-9004-68D4-2C4AD5A87D56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13513" r="14499"/>
          <a:stretch/>
        </p:blipFill>
        <p:spPr>
          <a:xfrm>
            <a:off x="3329258" y="4641740"/>
            <a:ext cx="1168400" cy="147523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A69E644C-1345-5073-6726-532B4FBF2517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2319"/>
          <a:stretch/>
        </p:blipFill>
        <p:spPr>
          <a:xfrm>
            <a:off x="2689808" y="1906747"/>
            <a:ext cx="1462532" cy="1475232"/>
          </a:xfrm>
          <a:prstGeom prst="rect">
            <a:avLst/>
          </a:prstGeom>
        </p:spPr>
      </p:pic>
      <p:grpSp>
        <p:nvGrpSpPr>
          <p:cNvPr id="41" name="Group 40">
            <a:extLst>
              <a:ext uri="{FF2B5EF4-FFF2-40B4-BE49-F238E27FC236}">
                <a16:creationId xmlns:a16="http://schemas.microsoft.com/office/drawing/2014/main" id="{C7C741B9-9778-E254-5E82-CC35E4F6331F}"/>
              </a:ext>
            </a:extLst>
          </p:cNvPr>
          <p:cNvGrpSpPr/>
          <p:nvPr/>
        </p:nvGrpSpPr>
        <p:grpSpPr>
          <a:xfrm>
            <a:off x="1595551" y="1900216"/>
            <a:ext cx="1123951" cy="1479803"/>
            <a:chOff x="140810" y="1669549"/>
            <a:chExt cx="1123951" cy="1479803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F19DAE1A-0C09-4317-8FF4-0C7F8EBF18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14435" t="15911" r="14241"/>
            <a:stretch/>
          </p:blipFill>
          <p:spPr>
            <a:xfrm>
              <a:off x="140810" y="1904999"/>
              <a:ext cx="1123951" cy="1244353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80BE803A-16EE-4B1C-E21F-010D440345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14435" r="47355" b="85805"/>
            <a:stretch/>
          </p:blipFill>
          <p:spPr>
            <a:xfrm>
              <a:off x="471011" y="1669549"/>
              <a:ext cx="602140" cy="210051"/>
            </a:xfrm>
            <a:prstGeom prst="rect">
              <a:avLst/>
            </a:prstGeom>
          </p:spPr>
        </p:pic>
      </p:grpSp>
      <p:pic>
        <p:nvPicPr>
          <p:cNvPr id="45" name="Picture 44">
            <a:extLst>
              <a:ext uri="{FF2B5EF4-FFF2-40B4-BE49-F238E27FC236}">
                <a16:creationId xmlns:a16="http://schemas.microsoft.com/office/drawing/2014/main" id="{1E852E66-4115-EA35-CAB4-DBBEB6589B5E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73024" t="17648" r="1291" b="52057"/>
          <a:stretch/>
        </p:blipFill>
        <p:spPr>
          <a:xfrm>
            <a:off x="5743175" y="5223718"/>
            <a:ext cx="929565" cy="749989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D5D1F8BB-DDED-E688-8749-115DEEEFDFB7}"/>
              </a:ext>
            </a:extLst>
          </p:cNvPr>
          <p:cNvSpPr txBox="1"/>
          <p:nvPr/>
        </p:nvSpPr>
        <p:spPr>
          <a:xfrm rot="16200000">
            <a:off x="-529739" y="3057832"/>
            <a:ext cx="13452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 Narrow" panose="020B0606020202030204" pitchFamily="34" charset="0"/>
              </a:rPr>
              <a:t>Concentration pg/mL</a:t>
            </a:r>
          </a:p>
        </p:txBody>
      </p:sp>
    </p:spTree>
    <p:extLst>
      <p:ext uri="{BB962C8B-B14F-4D97-AF65-F5344CB8AC3E}">
        <p14:creationId xmlns:p14="http://schemas.microsoft.com/office/powerpoint/2010/main" val="3991522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337</TotalTime>
  <Words>921</Words>
  <Application>Microsoft Office PowerPoint</Application>
  <PresentationFormat>A4 Paper (210x297 mm)</PresentationFormat>
  <Paragraphs>91</Paragraphs>
  <Slides>11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ola Andréa Martinez Murillo</dc:creator>
  <cp:lastModifiedBy>Paola Andréa Martinez Murillo</cp:lastModifiedBy>
  <cp:revision>529</cp:revision>
  <dcterms:created xsi:type="dcterms:W3CDTF">2021-10-05T09:12:45Z</dcterms:created>
  <dcterms:modified xsi:type="dcterms:W3CDTF">2023-11-27T16:35:37Z</dcterms:modified>
</cp:coreProperties>
</file>